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CE5165-9D69-09EE-AAB2-618D0ECECD99}"/>
              </a:ext>
            </a:extLst>
          </p:cNvPr>
          <p:cNvSpPr txBox="1"/>
          <p:nvPr/>
        </p:nvSpPr>
        <p:spPr>
          <a:xfrm>
            <a:off x="189941" y="4387262"/>
            <a:ext cx="647811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TGF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 is the predominant TGF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isoform expressed by immune cells in human Ewing tumors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xpression of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100" i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GFB1, TGFB2, and TGFB3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s shown all 7 human Ewing tumor samples processed for single cell RNA sequencing (n=3 samples enriched for CD45+ cells, n=4 samples with all cell types included). Inferred cell types are shown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een and yellow map of different types of cells&#10;&#10;AI-generated content may be incorrect.">
            <a:extLst>
              <a:ext uri="{FF2B5EF4-FFF2-40B4-BE49-F238E27FC236}">
                <a16:creationId xmlns:a16="http://schemas.microsoft.com/office/drawing/2014/main" id="{50556503-67D9-1361-1072-DE354D3143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80802"/>
            <a:ext cx="6529327" cy="32646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27854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5:41Z</dcterms:modified>
</cp:coreProperties>
</file>